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2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7712" autoAdjust="0"/>
  </p:normalViewPr>
  <p:slideViewPr>
    <p:cSldViewPr snapToGrid="0" snapToObjects="1">
      <p:cViewPr>
        <p:scale>
          <a:sx n="100" d="100"/>
          <a:sy n="100" d="100"/>
        </p:scale>
        <p:origin x="-1776" y="-64"/>
      </p:cViewPr>
      <p:guideLst>
        <p:guide orient="horz" pos="3168"/>
        <p:guide pos="2448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jeffreymarlow:Documents:Orphan%20Lab:Deuterated%20Methane:Tables%20and%20Figure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jeffreymarlow:Documents:Orphan%20Lab:Deuterated%20Methane:Tables%20and%20Figure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jeffreymarlow:Documents:Orphan%20Lab:Deuterated%20Methane:Tables%20and%20Figure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scatterChart>
        <c:scatterStyle val="lineMarker"/>
        <c:varyColors val="0"/>
        <c:ser>
          <c:idx val="1"/>
          <c:order val="0"/>
          <c:spPr>
            <a:ln w="47625">
              <a:noFill/>
            </a:ln>
            <a:effectLst/>
          </c:spPr>
          <c:marker>
            <c:symbol val="diamond"/>
            <c:size val="9"/>
            <c:spPr>
              <a:solidFill>
                <a:schemeClr val="accent2">
                  <a:lumMod val="60000"/>
                  <a:lumOff val="40000"/>
                </a:schemeClr>
              </a:solidFill>
              <a:ln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 delta'!$I$5:$I$12</c:f>
                <c:numCache>
                  <c:formatCode>General</c:formatCode>
                  <c:ptCount val="8"/>
                  <c:pt idx="0">
                    <c:v>3.847133670905442</c:v>
                  </c:pt>
                  <c:pt idx="1">
                    <c:v>5.401165084767193</c:v>
                  </c:pt>
                  <c:pt idx="2">
                    <c:v>4.37178169449267</c:v>
                  </c:pt>
                  <c:pt idx="3">
                    <c:v>4.426821062113231</c:v>
                  </c:pt>
                  <c:pt idx="4">
                    <c:v>3.578318371935996</c:v>
                  </c:pt>
                  <c:pt idx="5">
                    <c:v>4.528282421277806</c:v>
                  </c:pt>
                  <c:pt idx="6">
                    <c:v>2.98156197258208</c:v>
                  </c:pt>
                  <c:pt idx="7">
                    <c:v>3.313570412549879</c:v>
                  </c:pt>
                </c:numCache>
              </c:numRef>
            </c:plus>
            <c:minus>
              <c:numRef>
                <c:f>'Fig S1 delta'!$I$5:$I$12</c:f>
                <c:numCache>
                  <c:formatCode>General</c:formatCode>
                  <c:ptCount val="8"/>
                  <c:pt idx="0">
                    <c:v>3.847133670905442</c:v>
                  </c:pt>
                  <c:pt idx="1">
                    <c:v>5.401165084767193</c:v>
                  </c:pt>
                  <c:pt idx="2">
                    <c:v>4.37178169449267</c:v>
                  </c:pt>
                  <c:pt idx="3">
                    <c:v>4.426821062113231</c:v>
                  </c:pt>
                  <c:pt idx="4">
                    <c:v>3.578318371935996</c:v>
                  </c:pt>
                  <c:pt idx="5">
                    <c:v>4.528282421277806</c:v>
                  </c:pt>
                  <c:pt idx="6">
                    <c:v>2.98156197258208</c:v>
                  </c:pt>
                  <c:pt idx="7">
                    <c:v>3.313570412549879</c:v>
                  </c:pt>
                </c:numCache>
              </c:numRef>
            </c:minus>
          </c:errBars>
          <c:xVal>
            <c:numRef>
              <c:f>'Fig S1 delta'!$B$5:$B$12</c:f>
              <c:numCache>
                <c:formatCode>General</c:formatCode>
                <c:ptCount val="8"/>
                <c:pt idx="0">
                  <c:v>0.0</c:v>
                </c:pt>
                <c:pt idx="1">
                  <c:v>1.0</c:v>
                </c:pt>
                <c:pt idx="2">
                  <c:v>4.0</c:v>
                </c:pt>
                <c:pt idx="3">
                  <c:v>8.0</c:v>
                </c:pt>
                <c:pt idx="4">
                  <c:v>14.0</c:v>
                </c:pt>
                <c:pt idx="5">
                  <c:v>20.0</c:v>
                </c:pt>
                <c:pt idx="6">
                  <c:v>26.0</c:v>
                </c:pt>
                <c:pt idx="7">
                  <c:v>32.0</c:v>
                </c:pt>
              </c:numCache>
            </c:numRef>
          </c:xVal>
          <c:yVal>
            <c:numRef>
              <c:f>'Fig S1 delta'!$G$5:$G$12</c:f>
              <c:numCache>
                <c:formatCode>General</c:formatCode>
                <c:ptCount val="8"/>
                <c:pt idx="0">
                  <c:v>91.7295839753465</c:v>
                </c:pt>
                <c:pt idx="1">
                  <c:v>91.24550590652268</c:v>
                </c:pt>
                <c:pt idx="2">
                  <c:v>92.88263995891111</c:v>
                </c:pt>
                <c:pt idx="3">
                  <c:v>93.03672316384181</c:v>
                </c:pt>
                <c:pt idx="4">
                  <c:v>95.90010272213667</c:v>
                </c:pt>
                <c:pt idx="5">
                  <c:v>95.66820749871584</c:v>
                </c:pt>
                <c:pt idx="6">
                  <c:v>99.61350796096546</c:v>
                </c:pt>
                <c:pt idx="7">
                  <c:v>99.3576784797124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20800328"/>
        <c:axId val="-2117764952"/>
      </c:scatterChart>
      <c:valAx>
        <c:axId val="-212080032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200" dirty="0"/>
                  <a:t>Time (hours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17764952"/>
        <c:crosses val="autoZero"/>
        <c:crossBetween val="midCat"/>
      </c:valAx>
      <c:valAx>
        <c:axId val="-2117764952"/>
        <c:scaling>
          <c:orientation val="minMax"/>
          <c:max val="115.0"/>
          <c:min val="80.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/>
                </a:pPr>
                <a:r>
                  <a:rPr lang="el-GR" sz="1200"/>
                  <a:t>δD</a:t>
                </a:r>
                <a:endParaRPr lang="en-US" sz="1200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20800328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>
          <a:latin typeface="Times New Roman"/>
          <a:cs typeface="Times New Roman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1456903448566"/>
          <c:y val="0.0534979423868313"/>
          <c:w val="0.870763505831824"/>
          <c:h val="0.759917695473251"/>
        </c:manualLayout>
      </c:layout>
      <c:scatterChart>
        <c:scatterStyle val="lineMarker"/>
        <c:varyColors val="0"/>
        <c:ser>
          <c:idx val="0"/>
          <c:order val="0"/>
          <c:spPr>
            <a:ln w="47625">
              <a:noFill/>
            </a:ln>
            <a:effectLst/>
          </c:spPr>
          <c:marker>
            <c:symbol val="diamond"/>
            <c:size val="9"/>
            <c:spPr>
              <a:solidFill>
                <a:schemeClr val="accent5">
                  <a:lumMod val="75000"/>
                </a:schemeClr>
              </a:solidFill>
              <a:ln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 delta'!$E$5:$E$12</c:f>
                <c:numCache>
                  <c:formatCode>General</c:formatCode>
                  <c:ptCount val="8"/>
                  <c:pt idx="0">
                    <c:v>2.827075869988297</c:v>
                  </c:pt>
                  <c:pt idx="1">
                    <c:v>3.465279826125321</c:v>
                  </c:pt>
                  <c:pt idx="2">
                    <c:v>4.37267853819985</c:v>
                  </c:pt>
                  <c:pt idx="3">
                    <c:v>4.349914712346679</c:v>
                  </c:pt>
                  <c:pt idx="4">
                    <c:v>4.021805085514152</c:v>
                  </c:pt>
                  <c:pt idx="5">
                    <c:v>1.958748040128991</c:v>
                  </c:pt>
                  <c:pt idx="6">
                    <c:v>3.180559007591238</c:v>
                  </c:pt>
                  <c:pt idx="7">
                    <c:v>2.219597097402285</c:v>
                  </c:pt>
                </c:numCache>
              </c:numRef>
            </c:plus>
            <c:minus>
              <c:numRef>
                <c:f>'Fig S1 delta'!$E$5:$E$12</c:f>
                <c:numCache>
                  <c:formatCode>General</c:formatCode>
                  <c:ptCount val="8"/>
                  <c:pt idx="0">
                    <c:v>2.827075869988297</c:v>
                  </c:pt>
                  <c:pt idx="1">
                    <c:v>3.465279826125321</c:v>
                  </c:pt>
                  <c:pt idx="2">
                    <c:v>4.37267853819985</c:v>
                  </c:pt>
                  <c:pt idx="3">
                    <c:v>4.349914712346679</c:v>
                  </c:pt>
                  <c:pt idx="4">
                    <c:v>4.021805085514152</c:v>
                  </c:pt>
                  <c:pt idx="5">
                    <c:v>1.958748040128991</c:v>
                  </c:pt>
                  <c:pt idx="6">
                    <c:v>3.180559007591238</c:v>
                  </c:pt>
                  <c:pt idx="7">
                    <c:v>2.219597097402285</c:v>
                  </c:pt>
                </c:numCache>
              </c:numRef>
            </c:minus>
          </c:errBars>
          <c:xVal>
            <c:numRef>
              <c:f>'Fig S1 delta'!$B$5:$B$12</c:f>
              <c:numCache>
                <c:formatCode>General</c:formatCode>
                <c:ptCount val="8"/>
                <c:pt idx="0">
                  <c:v>0.0</c:v>
                </c:pt>
                <c:pt idx="1">
                  <c:v>1.0</c:v>
                </c:pt>
                <c:pt idx="2">
                  <c:v>4.0</c:v>
                </c:pt>
                <c:pt idx="3">
                  <c:v>8.0</c:v>
                </c:pt>
                <c:pt idx="4">
                  <c:v>14.0</c:v>
                </c:pt>
                <c:pt idx="5">
                  <c:v>20.0</c:v>
                </c:pt>
                <c:pt idx="6">
                  <c:v>26.0</c:v>
                </c:pt>
                <c:pt idx="7">
                  <c:v>32.0</c:v>
                </c:pt>
              </c:numCache>
            </c:numRef>
          </c:xVal>
          <c:yVal>
            <c:numRef>
              <c:f>'Fig S1 delta'!$C$5:$C$12</c:f>
              <c:numCache>
                <c:formatCode>General</c:formatCode>
                <c:ptCount val="8"/>
                <c:pt idx="0">
                  <c:v>92.34771443246025</c:v>
                </c:pt>
                <c:pt idx="1">
                  <c:v>90.89021571648652</c:v>
                </c:pt>
                <c:pt idx="2">
                  <c:v>94.13970210580337</c:v>
                </c:pt>
                <c:pt idx="3">
                  <c:v>96.70261941448375</c:v>
                </c:pt>
                <c:pt idx="4">
                  <c:v>92.96353364149956</c:v>
                </c:pt>
                <c:pt idx="5">
                  <c:v>99.8423215202875</c:v>
                </c:pt>
                <c:pt idx="6">
                  <c:v>101.1736004108883</c:v>
                </c:pt>
                <c:pt idx="7">
                  <c:v>100.546995377503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21048360"/>
        <c:axId val="-2117707992"/>
      </c:scatterChart>
      <c:valAx>
        <c:axId val="-21210483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-2117707992"/>
        <c:crosses val="autoZero"/>
        <c:crossBetween val="midCat"/>
      </c:valAx>
      <c:valAx>
        <c:axId val="-2117707992"/>
        <c:scaling>
          <c:orientation val="minMax"/>
          <c:max val="110.0"/>
          <c:min val="85.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/>
                </a:pPr>
                <a:r>
                  <a:rPr lang="el-GR" sz="1200"/>
                  <a:t>δD</a:t>
                </a:r>
                <a:endParaRPr lang="en-US" sz="1200" dirty="0"/>
              </a:p>
            </c:rich>
          </c:tx>
          <c:layout>
            <c:manualLayout>
              <c:xMode val="edge"/>
              <c:yMode val="edge"/>
              <c:x val="0.00445632798573975"/>
              <c:y val="0.39663102297398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-2121048360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>
          <a:latin typeface="Times New Roman"/>
          <a:cs typeface="Times New Roman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1456903448566"/>
          <c:y val="0.0534979423868313"/>
          <c:w val="0.870763505831824"/>
          <c:h val="0.759917695473251"/>
        </c:manualLayout>
      </c:layout>
      <c:scatterChart>
        <c:scatterStyle val="lineMarker"/>
        <c:varyColors val="0"/>
        <c:ser>
          <c:idx val="2"/>
          <c:order val="0"/>
          <c:spPr>
            <a:ln w="47625">
              <a:noFill/>
            </a:ln>
            <a:effectLst/>
          </c:spPr>
          <c:marker>
            <c:symbol val="diamond"/>
            <c:size val="9"/>
            <c:spPr>
              <a:solidFill>
                <a:schemeClr val="accent3">
                  <a:lumMod val="75000"/>
                </a:schemeClr>
              </a:solidFill>
              <a:ln>
                <a:noFil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Fig S1 delta'!$M$5:$M$12</c:f>
                <c:numCache>
                  <c:formatCode>General</c:formatCode>
                  <c:ptCount val="8"/>
                  <c:pt idx="0">
                    <c:v>2.890141315013</c:v>
                  </c:pt>
                  <c:pt idx="1">
                    <c:v>3.178210777231293</c:v>
                  </c:pt>
                  <c:pt idx="2">
                    <c:v>3.579448359368718</c:v>
                  </c:pt>
                  <c:pt idx="3">
                    <c:v>3.03820745564583</c:v>
                  </c:pt>
                  <c:pt idx="4">
                    <c:v>3.12821151319139</c:v>
                  </c:pt>
                  <c:pt idx="5">
                    <c:v>1.853725438132131</c:v>
                  </c:pt>
                  <c:pt idx="6">
                    <c:v>1.360729029531145</c:v>
                  </c:pt>
                  <c:pt idx="7">
                    <c:v>1.80274767722659</c:v>
                  </c:pt>
                </c:numCache>
              </c:numRef>
            </c:plus>
            <c:minus>
              <c:numRef>
                <c:f>'Fig S1 delta'!$M$5:$M$12</c:f>
                <c:numCache>
                  <c:formatCode>General</c:formatCode>
                  <c:ptCount val="8"/>
                  <c:pt idx="0">
                    <c:v>2.890141315013</c:v>
                  </c:pt>
                  <c:pt idx="1">
                    <c:v>3.178210777231293</c:v>
                  </c:pt>
                  <c:pt idx="2">
                    <c:v>3.579448359368718</c:v>
                  </c:pt>
                  <c:pt idx="3">
                    <c:v>3.03820745564583</c:v>
                  </c:pt>
                  <c:pt idx="4">
                    <c:v>3.12821151319139</c:v>
                  </c:pt>
                  <c:pt idx="5">
                    <c:v>1.853725438132131</c:v>
                  </c:pt>
                  <c:pt idx="6">
                    <c:v>1.360729029531145</c:v>
                  </c:pt>
                  <c:pt idx="7">
                    <c:v>1.80274767722659</c:v>
                  </c:pt>
                </c:numCache>
              </c:numRef>
            </c:minus>
          </c:errBars>
          <c:xVal>
            <c:numRef>
              <c:f>'Fig S1 delta'!$B$5:$B$12</c:f>
              <c:numCache>
                <c:formatCode>General</c:formatCode>
                <c:ptCount val="8"/>
                <c:pt idx="0">
                  <c:v>0.0</c:v>
                </c:pt>
                <c:pt idx="1">
                  <c:v>1.0</c:v>
                </c:pt>
                <c:pt idx="2">
                  <c:v>4.0</c:v>
                </c:pt>
                <c:pt idx="3">
                  <c:v>8.0</c:v>
                </c:pt>
                <c:pt idx="4">
                  <c:v>14.0</c:v>
                </c:pt>
                <c:pt idx="5">
                  <c:v>20.0</c:v>
                </c:pt>
                <c:pt idx="6">
                  <c:v>26.0</c:v>
                </c:pt>
                <c:pt idx="7">
                  <c:v>32.0</c:v>
                </c:pt>
              </c:numCache>
            </c:numRef>
          </c:xVal>
          <c:yVal>
            <c:numRef>
              <c:f>'Fig S1 delta'!$K$5:$K$12</c:f>
              <c:numCache>
                <c:formatCode>General</c:formatCode>
                <c:ptCount val="8"/>
                <c:pt idx="0">
                  <c:v>99.69183359013844</c:v>
                </c:pt>
                <c:pt idx="1">
                  <c:v>100.9621212121212</c:v>
                </c:pt>
                <c:pt idx="2">
                  <c:v>97.58731381612718</c:v>
                </c:pt>
                <c:pt idx="3">
                  <c:v>102.017205957884</c:v>
                </c:pt>
                <c:pt idx="4">
                  <c:v>103.161273754494</c:v>
                </c:pt>
                <c:pt idx="5">
                  <c:v>105.0128402670774</c:v>
                </c:pt>
                <c:pt idx="6">
                  <c:v>106.4047252182845</c:v>
                </c:pt>
                <c:pt idx="7">
                  <c:v>108.504108885464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117757896"/>
        <c:axId val="-2143191832"/>
      </c:scatterChart>
      <c:valAx>
        <c:axId val="-21177578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-2143191832"/>
        <c:crosses val="autoZero"/>
        <c:crossBetween val="midCat"/>
      </c:valAx>
      <c:valAx>
        <c:axId val="-2143191832"/>
        <c:scaling>
          <c:orientation val="minMax"/>
          <c:max val="110.0"/>
          <c:min val="85.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/>
                </a:pPr>
                <a:r>
                  <a:rPr lang="el-GR" sz="1200"/>
                  <a:t>δD</a:t>
                </a:r>
                <a:endParaRPr lang="en-US" sz="1200" dirty="0"/>
              </a:p>
            </c:rich>
          </c:tx>
          <c:layout>
            <c:manualLayout>
              <c:xMode val="edge"/>
              <c:yMode val="edge"/>
              <c:x val="0.00445632798573975"/>
              <c:y val="0.39663102297398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-2117757896"/>
        <c:crosses val="autoZero"/>
        <c:crossBetween val="midCat"/>
      </c:valAx>
    </c:plotArea>
    <c:plotVisOnly val="1"/>
    <c:dispBlanksAs val="gap"/>
    <c:showDLblsOverMax val="0"/>
  </c:chart>
  <c:txPr>
    <a:bodyPr/>
    <a:lstStyle/>
    <a:p>
      <a:pPr>
        <a:defRPr>
          <a:latin typeface="Times New Roman"/>
          <a:cs typeface="Times New Roman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6E8B635-E9C3-D147-9420-A0BC6BCBFAD1}" type="datetimeFigureOut">
              <a:rPr lang="en-US" smtClean="0"/>
              <a:t>7/31/17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03438" y="685800"/>
            <a:ext cx="265112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05400E4-6A63-584E-9BDD-F21BB44CCE1A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120588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05400E4-6A63-584E-9BDD-F21BB44CCE1A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212466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3124624"/>
            <a:ext cx="6606540" cy="215603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5860" y="5699760"/>
            <a:ext cx="5440680" cy="25704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29911-FF93-664E-86B0-FF9DE8BB9031}" type="datetimeFigureOut">
              <a:rPr lang="en-US" smtClean="0"/>
              <a:t>7/31/17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37A2D-F654-7840-834F-DF18A768C52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537941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29911-FF93-664E-86B0-FF9DE8BB9031}" type="datetimeFigureOut">
              <a:rPr lang="en-US" smtClean="0"/>
              <a:t>7/31/17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37A2D-F654-7840-834F-DF18A768C52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768439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634990" y="402803"/>
            <a:ext cx="1748790" cy="858223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88620" y="402803"/>
            <a:ext cx="5116830" cy="858223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29911-FF93-664E-86B0-FF9DE8BB9031}" type="datetimeFigureOut">
              <a:rPr lang="en-US" smtClean="0"/>
              <a:t>7/31/17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37A2D-F654-7840-834F-DF18A768C52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680229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29911-FF93-664E-86B0-FF9DE8BB9031}" type="datetimeFigureOut">
              <a:rPr lang="en-US" smtClean="0"/>
              <a:t>7/31/17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37A2D-F654-7840-834F-DF18A768C52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70556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3966" y="6463454"/>
            <a:ext cx="6606540" cy="199771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3966" y="4263180"/>
            <a:ext cx="6606540" cy="2200274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29911-FF93-664E-86B0-FF9DE8BB9031}" type="datetimeFigureOut">
              <a:rPr lang="en-US" smtClean="0"/>
              <a:t>7/31/17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37A2D-F654-7840-834F-DF18A768C52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99470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88620" y="2346961"/>
            <a:ext cx="3432810" cy="663807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50970" y="2346961"/>
            <a:ext cx="3432810" cy="663807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29911-FF93-664E-86B0-FF9DE8BB9031}" type="datetimeFigureOut">
              <a:rPr lang="en-US" smtClean="0"/>
              <a:t>7/31/17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37A2D-F654-7840-834F-DF18A768C52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502032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251499"/>
            <a:ext cx="3434160" cy="93831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8620" y="3189817"/>
            <a:ext cx="3434160" cy="579522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48272" y="2251499"/>
            <a:ext cx="3435509" cy="93831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48272" y="3189817"/>
            <a:ext cx="3435509" cy="579522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29911-FF93-664E-86B0-FF9DE8BB9031}" type="datetimeFigureOut">
              <a:rPr lang="en-US" smtClean="0"/>
              <a:t>7/31/17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37A2D-F654-7840-834F-DF18A768C52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190446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29911-FF93-664E-86B0-FF9DE8BB9031}" type="datetimeFigureOut">
              <a:rPr lang="en-US" smtClean="0"/>
              <a:t>7/31/17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37A2D-F654-7840-834F-DF18A768C52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754795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29911-FF93-664E-86B0-FF9DE8BB9031}" type="datetimeFigureOut">
              <a:rPr lang="en-US" smtClean="0"/>
              <a:t>7/31/17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37A2D-F654-7840-834F-DF18A768C52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991893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0" y="400473"/>
            <a:ext cx="2557066" cy="170434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38792" y="400474"/>
            <a:ext cx="4344988" cy="858456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8620" y="2104814"/>
            <a:ext cx="2557066" cy="688022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29911-FF93-664E-86B0-FF9DE8BB9031}" type="datetimeFigureOut">
              <a:rPr lang="en-US" smtClean="0"/>
              <a:t>7/31/17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37A2D-F654-7840-834F-DF18A768C52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428009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23445" y="7040880"/>
            <a:ext cx="4663440" cy="83121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523445" y="898737"/>
            <a:ext cx="4663440" cy="60350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23445" y="7872096"/>
            <a:ext cx="4663440" cy="118046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029911-FF93-664E-86B0-FF9DE8BB9031}" type="datetimeFigureOut">
              <a:rPr lang="en-US" smtClean="0"/>
              <a:t>7/31/17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37A2D-F654-7840-834F-DF18A768C52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598149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346961"/>
            <a:ext cx="6995160" cy="66380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88620" y="9322647"/>
            <a:ext cx="18135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029911-FF93-664E-86B0-FF9DE8BB9031}" type="datetimeFigureOut">
              <a:rPr lang="en-US" smtClean="0"/>
              <a:t>7/31/17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55570" y="9322647"/>
            <a:ext cx="24612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70220" y="9322647"/>
            <a:ext cx="18135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B37A2D-F654-7840-834F-DF18A768C527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197488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5" Type="http://schemas.openxmlformats.org/officeDocument/2006/relationships/chart" Target="../charts/chart3.xml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" name="Chart 1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56085298"/>
              </p:ext>
            </p:extLst>
          </p:nvPr>
        </p:nvGraphicFramePr>
        <p:xfrm>
          <a:off x="388620" y="6106521"/>
          <a:ext cx="7095744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Chart 3"/>
          <p:cNvGraphicFramePr/>
          <p:nvPr>
            <p:extLst>
              <p:ext uri="{D42A27DB-BD31-4B8C-83A1-F6EECF244321}">
                <p14:modId xmlns:p14="http://schemas.microsoft.com/office/powerpoint/2010/main" val="2420947072"/>
              </p:ext>
            </p:extLst>
          </p:nvPr>
        </p:nvGraphicFramePr>
        <p:xfrm>
          <a:off x="388620" y="3794914"/>
          <a:ext cx="7091680" cy="25603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92980" y="169265"/>
            <a:ext cx="10888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/>
                <a:cs typeface="Times New Roman"/>
              </a:rPr>
              <a:t>Figure S2</a:t>
            </a:r>
            <a:endParaRPr lang="en-US" dirty="0">
              <a:latin typeface="Times New Roman"/>
              <a:cs typeface="Times New Roman"/>
            </a:endParaRPr>
          </a:p>
        </p:txBody>
      </p:sp>
      <p:graphicFrame>
        <p:nvGraphicFramePr>
          <p:cNvPr id="7" name="Chart 6"/>
          <p:cNvGraphicFramePr/>
          <p:nvPr>
            <p:extLst>
              <p:ext uri="{D42A27DB-BD31-4B8C-83A1-F6EECF244321}">
                <p14:modId xmlns:p14="http://schemas.microsoft.com/office/powerpoint/2010/main" val="4266626459"/>
              </p:ext>
            </p:extLst>
          </p:nvPr>
        </p:nvGraphicFramePr>
        <p:xfrm>
          <a:off x="388620" y="1419760"/>
          <a:ext cx="7091680" cy="25529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cxnSp>
        <p:nvCxnSpPr>
          <p:cNvPr id="3" name="Straight Connector 2"/>
          <p:cNvCxnSpPr/>
          <p:nvPr/>
        </p:nvCxnSpPr>
        <p:spPr>
          <a:xfrm>
            <a:off x="1111248" y="2130960"/>
            <a:ext cx="5687568" cy="0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>
            <a:off x="1111249" y="2578635"/>
            <a:ext cx="5687568" cy="0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>
            <a:off x="1108074" y="5086885"/>
            <a:ext cx="5687568" cy="0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1111249" y="5528210"/>
            <a:ext cx="5687568" cy="0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1108074" y="7347946"/>
            <a:ext cx="5687568" cy="0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1108074" y="7773396"/>
            <a:ext cx="5687568" cy="0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587486" y="841441"/>
            <a:ext cx="694361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Times New Roman"/>
                <a:cs typeface="Times New Roman"/>
              </a:rPr>
              <a:t>Determining the Resolving Power of the </a:t>
            </a:r>
          </a:p>
          <a:p>
            <a:pPr algn="ctr"/>
            <a:r>
              <a:rPr lang="en-US" dirty="0" smtClean="0">
                <a:latin typeface="Times New Roman"/>
                <a:cs typeface="Times New Roman"/>
              </a:rPr>
              <a:t>Monodeuterated Methane Rate Measurement Technique</a:t>
            </a:r>
            <a:endParaRPr lang="en-US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660028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749</TotalTime>
  <Words>21</Words>
  <Application>Microsoft Macintosh PowerPoint</Application>
  <PresentationFormat>Custom</PresentationFormat>
  <Paragraphs>8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Harvard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ffrey Marlow</dc:creator>
  <cp:lastModifiedBy>Jeffrey Marlow</cp:lastModifiedBy>
  <cp:revision>78</cp:revision>
  <dcterms:created xsi:type="dcterms:W3CDTF">2016-05-10T17:00:52Z</dcterms:created>
  <dcterms:modified xsi:type="dcterms:W3CDTF">2017-07-31T21:52:16Z</dcterms:modified>
</cp:coreProperties>
</file>